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3960588-C439-C6C1-1CB9-0C2D02E8BF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0FBFD9B4-D28A-0EC3-AE50-3103E96743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6653A7E-A1B9-6477-D9EC-5ECF29AC8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6535590-3A62-5A39-6110-FD51EBAD4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D973E15-5888-F5D4-BE56-49710BFB2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2420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8D84029-8E84-D3BB-626E-07EA2EEA42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1001F87-5647-E9E1-17DE-8400407A2D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DE24669-5EC4-D081-E8D7-76A41BCC4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4C8ECFF-C7E0-C266-95B4-95B66D547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3D62492B-DB30-9218-968A-CC44D1DC1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82776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7ADBDE58-E723-1E4C-91C8-8FA4A54012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1F1B3CBB-33E3-0C6D-C828-324F426192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5651708-872F-D727-139F-ABE89EA56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C7B8AB5-78A5-95A0-87DB-EE4928F52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8D69349-9FCA-C9B4-7BB7-4C16B3951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50872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F5FCEBE-F235-C06C-E3E8-31A1E82F9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1B15218-29D3-48DF-B01A-0AE04EBACF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3F6C01C3-FD67-D778-5E5B-EE80144A6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2E34815-0C4C-5F06-2D59-E70AB5412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2494CD0-E7D1-B280-5D32-05B538B83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9369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862072B-742D-1A94-71E4-F863E51A9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80BF2A08-012A-98C7-0EDC-F89F8FE0BA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E78029D-FC0E-AFA2-7EB5-3344B6EA2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9B8E080-3533-A721-A58E-A5CA0A772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41551C6-0B08-3778-3B3D-3EE696438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84865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20C1D03-16BD-7C67-F1D7-286F004FF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475A51E-65D6-6CA0-29CA-51E4DE1DEC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F3172AB-7095-BFC6-F08F-BAC827979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6F18DC4-D996-867D-84FB-1D948643D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4135CE3-6D37-13AE-3270-C1B7AEE88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AC5A0698-1F81-1290-A4A2-0DE297CEB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4686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A3483A6-0A0A-DCF7-DE48-D6F0346CFC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5155209-BDD6-5424-C138-60D7BD3F9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BA05D9D1-394A-ABA0-26A5-D73A765F7E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3C270203-DC31-4261-7C75-04251E9DD8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19D435E1-96E8-53D0-3CAE-33A8DE5E0E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B7379367-52D0-AA0C-C47F-803DDD283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797089A0-285B-492C-21BD-8B23D9EE0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079727A3-311A-B128-60BC-0DEB5FF6B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3611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D8B47E9-DFD9-2111-382D-8BC266706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49CF52D9-0BE3-70BB-A9AE-E5E9D3281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F282627E-BDC5-3514-DF2B-B59E4ADED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23B48A40-03DE-0B14-C515-CCB57D04D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6297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85DA7FDE-7868-07FC-EA5A-6467C55CC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95106691-E4CA-ABFD-C160-C49F74B8B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9CF2A3CE-B432-C604-939B-45041B63F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63547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186107E-8103-9EC5-37E4-97843FD09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2F867A12-7CD0-286E-893B-0253CF2F20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57C1B09-F64F-607A-97FB-0FE2D1572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FB0AEB8F-DBFD-555A-9157-2A4EE2444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A6CAD2F-0FC0-CDC4-4261-DE115CFE6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DDC2068A-73C1-2AC7-940F-A3C5DDDA0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23778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37AFE73-DDD3-BF91-6926-20F5894AE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C0874AA1-604D-BB1A-07AE-C5EAD8DA4E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EB336AFE-0879-DB23-5C74-2BBD24C82C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936CFB5-A2DD-4396-2F61-513593A31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5AE43D8-2CEA-489B-FAFA-53A821E84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BDE265DF-D7FE-02CF-B8E2-855AF58D9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95042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7DD76939-71DE-74EB-D7C7-C2B7A891E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0D5BA84-A188-C66E-A4E5-DC8E6C4125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37DFE24-9E92-3C6C-F767-9B1B9F8C07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04C3A-64B6-4336-BDB6-7CEC60570FCC}" type="datetimeFigureOut">
              <a:rPr lang="sv-SE" smtClean="0"/>
              <a:t>2024-09-25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9D6E4A1-C7C2-AFBE-99E0-EE0F511480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651ED8A-9BFC-A50C-0A90-2B680E3F58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5E38A-B8AB-4DB9-8BC6-BDFDEA22067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25155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4D993B3-674A-5064-4986-5E7A68C61A0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teral abdominal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rnias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4C17A036-F9CC-9FF2-1A9D-1FD802E998C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965898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0BB4C80-C722-DE30-BC7F-C7DDA30ABE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5930CE21-0DD9-1837-C34D-8F9C414D13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stly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 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dominal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 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ptible or palpable by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amination or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ing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?</a:t>
            </a:r>
            <a:b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YES 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Hernia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ondly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normality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abdominal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lin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rusion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abdominal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ll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?</a:t>
            </a:r>
            <a:b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NO 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typ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 1</a:t>
            </a:r>
            <a:b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</a:b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If YES 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typ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 2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rdly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 the gap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ated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verse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dominal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nal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lique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r>
              <a:rPr lang="sv-SE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sv-SE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yer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class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 A</a:t>
            </a:r>
            <a:b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</a:b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If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both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yers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 </a:t>
            </a:r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class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 B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162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E000376-A880-0AB6-8498-54B3249D95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4 </a:t>
            </a:r>
            <a:r>
              <a:rPr lang="sv-SE" dirty="0" err="1"/>
              <a:t>Type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IH</a:t>
            </a:r>
          </a:p>
        </p:txBody>
      </p:sp>
      <p:pic>
        <p:nvPicPr>
          <p:cNvPr id="5" name="Platshållare för innehåll 4" descr="En bild som visar text, flera&#10;&#10;Automatiskt genererad beskrivning">
            <a:extLst>
              <a:ext uri="{FF2B5EF4-FFF2-40B4-BE49-F238E27FC236}">
                <a16:creationId xmlns:a16="http://schemas.microsoft.com/office/drawing/2014/main" id="{19A4C5F5-F516-D327-C2AB-61B6B9F2526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286" y="-5745"/>
            <a:ext cx="7286714" cy="6863746"/>
          </a:xfrm>
        </p:spPr>
      </p:pic>
    </p:spTree>
    <p:extLst>
      <p:ext uri="{BB962C8B-B14F-4D97-AF65-F5344CB8AC3E}">
        <p14:creationId xmlns:p14="http://schemas.microsoft.com/office/powerpoint/2010/main" val="3898224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97</Words>
  <Application>Microsoft Office PowerPoint</Application>
  <PresentationFormat>Bredbild</PresentationFormat>
  <Paragraphs>8</Paragraphs>
  <Slides>3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-tema</vt:lpstr>
      <vt:lpstr>New classification of lateral abdominal wall hernias</vt:lpstr>
      <vt:lpstr>Parameters</vt:lpstr>
      <vt:lpstr>4 Types of IH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w classification for lateral abdominal wall hernias</dc:title>
  <dc:creator>Kristoffer Huitfeldt Sola</dc:creator>
  <cp:lastModifiedBy>Kristoffer Sola</cp:lastModifiedBy>
  <cp:revision>12</cp:revision>
  <dcterms:created xsi:type="dcterms:W3CDTF">2023-03-28T09:16:41Z</dcterms:created>
  <dcterms:modified xsi:type="dcterms:W3CDTF">2024-09-25T11:30:46Z</dcterms:modified>
</cp:coreProperties>
</file>